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987" autoAdjust="0"/>
    <p:restoredTop sz="94660"/>
  </p:normalViewPr>
  <p:slideViewPr>
    <p:cSldViewPr snapToGrid="0">
      <p:cViewPr varScale="1">
        <p:scale>
          <a:sx n="67" d="100"/>
          <a:sy n="67" d="100"/>
        </p:scale>
        <p:origin x="96" y="33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B9DE1C2-BE4D-4E2C-97F5-31EE105805AA}" type="datetimeFigureOut">
              <a:rPr lang="en-GB" smtClean="0"/>
              <a:t>07/06/2021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DDD217A-F889-47A7-821D-B81EE232E57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1123018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GB" dirty="0"/>
              <a:t>Supplementary Table 1: Breakdown of the division of patients into training, test and  independent validation sets. Numbers in parenthesis indicate heterogenous patients.</a:t>
            </a:r>
          </a:p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DDD217A-F889-47A7-821D-B81EE232E573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1273690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6654C0D-AE0E-46ED-AC34-6E60FAE048A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BD648D1F-A2AD-4A19-A3E0-ACB8946B3BD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EB06CFE-99A0-4DAF-BB16-93CDE51DE86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5911E9-4920-4B99-8823-79B657BE78AB}" type="datetimeFigureOut">
              <a:rPr lang="en-GB" smtClean="0"/>
              <a:t>07/06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AAEA75D-C2D4-4117-9945-25372834652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239B906-2B49-4D0C-8917-ACAD6C8FA64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B5D147-63B8-4B58-9181-9A19427A2DA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9510163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54EA4CE-68B3-487A-B588-3327082EB30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228D8B0-0AE3-4856-A323-4F894094EBB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FD661F8-CA77-4BA8-8B40-46669E9E887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5911E9-4920-4B99-8823-79B657BE78AB}" type="datetimeFigureOut">
              <a:rPr lang="en-GB" smtClean="0"/>
              <a:t>07/06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11A5F09-290E-4C6F-A528-61F12466381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3A8C5DE-C296-4F97-8952-63E3B62B0A2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B5D147-63B8-4B58-9181-9A19427A2DA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8543616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C11D7DD9-83C8-4073-B5D6-E658F636CC8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D078810-D269-4656-A528-D501AFC2956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7D199B3-3886-49E0-978B-8EDAC1CF35C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5911E9-4920-4B99-8823-79B657BE78AB}" type="datetimeFigureOut">
              <a:rPr lang="en-GB" smtClean="0"/>
              <a:t>07/06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223D5C0-C199-42C9-B219-73EEFE7926E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5A7B44F-EE71-4760-80FA-0BC23DBC664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B5D147-63B8-4B58-9181-9A19427A2DA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452606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2C1ED0A-2D0C-41D9-B37F-ED459BF0CD9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65EB1AA-821A-49DA-85E5-74B3B37F157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3662111-8702-45B0-9143-B99F945B3BA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5911E9-4920-4B99-8823-79B657BE78AB}" type="datetimeFigureOut">
              <a:rPr lang="en-GB" smtClean="0"/>
              <a:t>07/06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C582CED-1D7E-4DAA-9DD9-0DDDFCFC357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113D616-EA0C-4A1F-8FD4-121C855FBD8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B5D147-63B8-4B58-9181-9A19427A2DA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9432811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6E04398-AF93-472A-BAA7-CEB58EE68A0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C0DBDD5-C49E-4950-B660-A48743DBA73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615A56C-9A8F-4B33-9C25-474834D9414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5911E9-4920-4B99-8823-79B657BE78AB}" type="datetimeFigureOut">
              <a:rPr lang="en-GB" smtClean="0"/>
              <a:t>07/06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4E93F56-9E1E-4069-90EC-EBB5399DB33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82042DE-5005-48C2-82B4-3262C0409AF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B5D147-63B8-4B58-9181-9A19427A2DA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6939623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5771B88-1A74-4FF2-9746-19CBCBF8CF8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69660A8-7E59-4925-A37B-B2EE07D608C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3338DC1-3F07-42B1-ACA2-2AC873D89E2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9D90137-0434-4EFC-A9BD-EB5C4452565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5911E9-4920-4B99-8823-79B657BE78AB}" type="datetimeFigureOut">
              <a:rPr lang="en-GB" smtClean="0"/>
              <a:t>07/06/2021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F7CB4CC-F86C-4791-A982-9F1D50FF405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C651841-00F2-4F73-BEC8-41CB2F7B9E4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B5D147-63B8-4B58-9181-9A19427A2DA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0363105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066FD5A-C55D-4FE1-BDB3-1BE070B8C12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45464F3-B4A6-426A-9959-47383D52DE7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3F6CD58-3D65-4BDE-9EE8-008C147DC5E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41057EEC-CDDD-435B-95D6-0C1AC779804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75F0476D-5A25-4251-BAE7-22880C07BBC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CC3ADF63-7D0B-4A3D-A6D1-310A8FC9B99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5911E9-4920-4B99-8823-79B657BE78AB}" type="datetimeFigureOut">
              <a:rPr lang="en-GB" smtClean="0"/>
              <a:t>07/06/2021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DB4E3941-919E-45E8-8D21-C76ED9E15AB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B6544C10-88E8-48B7-A877-6EB106E082F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B5D147-63B8-4B58-9181-9A19427A2DA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4761727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47A400D-5507-4623-A00D-DF660F24531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9001A5D4-78D8-4054-9958-E009EE7F332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5911E9-4920-4B99-8823-79B657BE78AB}" type="datetimeFigureOut">
              <a:rPr lang="en-GB" smtClean="0"/>
              <a:t>07/06/2021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CDC77D45-93F3-44D1-9D53-AA635A377A5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CE691182-B172-4686-89EF-61E55F7436E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B5D147-63B8-4B58-9181-9A19427A2DA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5198343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2A3247C6-47F3-44AE-B3A5-834C4835FA9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5911E9-4920-4B99-8823-79B657BE78AB}" type="datetimeFigureOut">
              <a:rPr lang="en-GB" smtClean="0"/>
              <a:t>07/06/2021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535A7E47-217D-4916-86F1-05F10AEEDB0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6DBD28AA-8007-4DF5-A39A-23D3A0B33EB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B5D147-63B8-4B58-9181-9A19427A2DA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934574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F6D8821-F06C-454E-971A-F09591F6807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C8E637C-A36C-48CF-ACBC-E9E31D6BC53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7463972-722C-42E9-B8F5-2DCF4916908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3E16CCD-83DE-43B1-AD70-25E2C21D0E2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5911E9-4920-4B99-8823-79B657BE78AB}" type="datetimeFigureOut">
              <a:rPr lang="en-GB" smtClean="0"/>
              <a:t>07/06/2021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0ABCFDD-1705-4449-BE05-87F9269FAF8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C0EFD58-790F-44AD-A497-A31359CC3FC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B5D147-63B8-4B58-9181-9A19427A2DA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3305229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9188514-60FC-488A-9E29-CABA1AADB70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84784C9F-D46A-4882-BD66-7CB220651A8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359908E-A7C8-4756-B5FB-4B322D812B4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6963E15-7A8B-4A8A-B66E-5384ED04AE9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5911E9-4920-4B99-8823-79B657BE78AB}" type="datetimeFigureOut">
              <a:rPr lang="en-GB" smtClean="0"/>
              <a:t>07/06/2021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9020905-CEB0-4CA5-BFFD-4ED4A8D0C25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05F0152-032A-4E9D-AAEE-56C564A9FE4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B5D147-63B8-4B58-9181-9A19427A2DA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0475229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6B249156-E8E6-40B6-BE5F-2C23ED73345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7654BD9-2A8A-4283-BFF7-B63978E324E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C09067F-2A5F-49BA-A165-14D520A56C6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B5911E9-4920-4B99-8823-79B657BE78AB}" type="datetimeFigureOut">
              <a:rPr lang="en-GB" smtClean="0"/>
              <a:t>07/06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BC2D594-9043-4067-AE70-BF189E10DFE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19B843E-AC16-4E6A-8011-D93F3BEA683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3B5D147-63B8-4B58-9181-9A19427A2DA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9090489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31F33D56-FD84-4607-ABF7-E7F880B5CC53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272950204"/>
              </p:ext>
            </p:extLst>
          </p:nvPr>
        </p:nvGraphicFramePr>
        <p:xfrm>
          <a:off x="1826309" y="2086413"/>
          <a:ext cx="8539382" cy="2685174"/>
        </p:xfrm>
        <a:graphic>
          <a:graphicData uri="http://schemas.openxmlformats.org/drawingml/2006/table">
            <a:tbl>
              <a:tblPr>
                <a:tableStyleId>{616DA210-FB5B-4158-B5E0-FEB733F419BA}</a:tableStyleId>
              </a:tblPr>
              <a:tblGrid>
                <a:gridCol w="576685">
                  <a:extLst>
                    <a:ext uri="{9D8B030D-6E8A-4147-A177-3AD203B41FA5}">
                      <a16:colId xmlns:a16="http://schemas.microsoft.com/office/drawing/2014/main" val="4206100503"/>
                    </a:ext>
                  </a:extLst>
                </a:gridCol>
                <a:gridCol w="632136">
                  <a:extLst>
                    <a:ext uri="{9D8B030D-6E8A-4147-A177-3AD203B41FA5}">
                      <a16:colId xmlns:a16="http://schemas.microsoft.com/office/drawing/2014/main" val="777853354"/>
                    </a:ext>
                  </a:extLst>
                </a:gridCol>
                <a:gridCol w="454694">
                  <a:extLst>
                    <a:ext uri="{9D8B030D-6E8A-4147-A177-3AD203B41FA5}">
                      <a16:colId xmlns:a16="http://schemas.microsoft.com/office/drawing/2014/main" val="3190923619"/>
                    </a:ext>
                  </a:extLst>
                </a:gridCol>
                <a:gridCol w="1253183">
                  <a:extLst>
                    <a:ext uri="{9D8B030D-6E8A-4147-A177-3AD203B41FA5}">
                      <a16:colId xmlns:a16="http://schemas.microsoft.com/office/drawing/2014/main" val="3096806034"/>
                    </a:ext>
                  </a:extLst>
                </a:gridCol>
                <a:gridCol w="632136">
                  <a:extLst>
                    <a:ext uri="{9D8B030D-6E8A-4147-A177-3AD203B41FA5}">
                      <a16:colId xmlns:a16="http://schemas.microsoft.com/office/drawing/2014/main" val="3330244852"/>
                    </a:ext>
                  </a:extLst>
                </a:gridCol>
                <a:gridCol w="454694">
                  <a:extLst>
                    <a:ext uri="{9D8B030D-6E8A-4147-A177-3AD203B41FA5}">
                      <a16:colId xmlns:a16="http://schemas.microsoft.com/office/drawing/2014/main" val="3409601454"/>
                    </a:ext>
                  </a:extLst>
                </a:gridCol>
                <a:gridCol w="787398">
                  <a:extLst>
                    <a:ext uri="{9D8B030D-6E8A-4147-A177-3AD203B41FA5}">
                      <a16:colId xmlns:a16="http://schemas.microsoft.com/office/drawing/2014/main" val="2386184404"/>
                    </a:ext>
                  </a:extLst>
                </a:gridCol>
                <a:gridCol w="632136">
                  <a:extLst>
                    <a:ext uri="{9D8B030D-6E8A-4147-A177-3AD203B41FA5}">
                      <a16:colId xmlns:a16="http://schemas.microsoft.com/office/drawing/2014/main" val="3142582705"/>
                    </a:ext>
                  </a:extLst>
                </a:gridCol>
                <a:gridCol w="454694">
                  <a:extLst>
                    <a:ext uri="{9D8B030D-6E8A-4147-A177-3AD203B41FA5}">
                      <a16:colId xmlns:a16="http://schemas.microsoft.com/office/drawing/2014/main" val="1454366081"/>
                    </a:ext>
                  </a:extLst>
                </a:gridCol>
                <a:gridCol w="787398">
                  <a:extLst>
                    <a:ext uri="{9D8B030D-6E8A-4147-A177-3AD203B41FA5}">
                      <a16:colId xmlns:a16="http://schemas.microsoft.com/office/drawing/2014/main" val="3174490366"/>
                    </a:ext>
                  </a:extLst>
                </a:gridCol>
                <a:gridCol w="632136">
                  <a:extLst>
                    <a:ext uri="{9D8B030D-6E8A-4147-A177-3AD203B41FA5}">
                      <a16:colId xmlns:a16="http://schemas.microsoft.com/office/drawing/2014/main" val="4245245932"/>
                    </a:ext>
                  </a:extLst>
                </a:gridCol>
                <a:gridCol w="454694">
                  <a:extLst>
                    <a:ext uri="{9D8B030D-6E8A-4147-A177-3AD203B41FA5}">
                      <a16:colId xmlns:a16="http://schemas.microsoft.com/office/drawing/2014/main" val="1756578028"/>
                    </a:ext>
                  </a:extLst>
                </a:gridCol>
                <a:gridCol w="787398">
                  <a:extLst>
                    <a:ext uri="{9D8B030D-6E8A-4147-A177-3AD203B41FA5}">
                      <a16:colId xmlns:a16="http://schemas.microsoft.com/office/drawing/2014/main" val="1578095779"/>
                    </a:ext>
                  </a:extLst>
                </a:gridCol>
              </a:tblGrid>
              <a:tr h="447529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1" u="none" strike="noStrike" dirty="0">
                          <a:solidFill>
                            <a:srgbClr val="000000"/>
                          </a:solidFill>
                          <a:effectLst/>
                        </a:rPr>
                        <a:t>Image set</a:t>
                      </a:r>
                      <a:endParaRPr lang="en-GB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 gridSpan="6">
                  <a:txBody>
                    <a:bodyPr/>
                    <a:lstStyle/>
                    <a:p>
                      <a:pPr algn="ctr" fontAlgn="b"/>
                      <a:r>
                        <a:rPr lang="en-GB" sz="1100" b="1" u="none" strike="noStrike" dirty="0">
                          <a:effectLst/>
                        </a:rPr>
                        <a:t>Unbalanced</a:t>
                      </a:r>
                      <a:endParaRPr lang="en-GB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gridSpan="6">
                  <a:txBody>
                    <a:bodyPr/>
                    <a:lstStyle/>
                    <a:p>
                      <a:pPr algn="ctr" fontAlgn="b"/>
                      <a:r>
                        <a:rPr lang="en-GB" sz="1100" b="1" u="none" strike="noStrike" dirty="0">
                          <a:effectLst/>
                        </a:rPr>
                        <a:t>Balanced</a:t>
                      </a:r>
                      <a:endParaRPr lang="en-GB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925884264"/>
                  </a:ext>
                </a:extLst>
              </a:tr>
              <a:tr h="447529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1" u="none" strike="noStrike" dirty="0">
                          <a:solidFill>
                            <a:srgbClr val="000000"/>
                          </a:solidFill>
                          <a:effectLst/>
                        </a:rPr>
                        <a:t>Maturity</a:t>
                      </a:r>
                    </a:p>
                    <a:p>
                      <a:pPr algn="ctr" fontAlgn="b"/>
                      <a:r>
                        <a:rPr lang="en-GB" sz="1100" b="1" u="none" strike="noStrike" dirty="0">
                          <a:solidFill>
                            <a:srgbClr val="000000"/>
                          </a:solidFill>
                          <a:effectLst/>
                        </a:rPr>
                        <a:t>Status</a:t>
                      </a:r>
                      <a:endParaRPr lang="en-GB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 dirty="0">
                          <a:effectLst/>
                        </a:rPr>
                        <a:t>Immature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 dirty="0">
                          <a:effectLst/>
                        </a:rPr>
                        <a:t>Mature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 dirty="0">
                          <a:effectLst/>
                        </a:rPr>
                        <a:t>Immature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Mature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396674209"/>
                  </a:ext>
                </a:extLst>
              </a:tr>
              <a:tr h="447529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1" u="none" strike="noStrike" dirty="0">
                          <a:solidFill>
                            <a:srgbClr val="000000"/>
                          </a:solidFill>
                          <a:effectLst/>
                        </a:rPr>
                        <a:t>Set</a:t>
                      </a:r>
                      <a:endParaRPr lang="en-GB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Training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Test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 dirty="0">
                          <a:effectLst/>
                        </a:rPr>
                        <a:t>Validation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 dirty="0">
                          <a:effectLst/>
                        </a:rPr>
                        <a:t>Training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 dirty="0">
                          <a:effectLst/>
                        </a:rPr>
                        <a:t>Test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 dirty="0">
                          <a:effectLst/>
                        </a:rPr>
                        <a:t>Validation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 dirty="0">
                          <a:effectLst/>
                        </a:rPr>
                        <a:t>Training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 dirty="0">
                          <a:effectLst/>
                        </a:rPr>
                        <a:t>Test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 dirty="0">
                          <a:effectLst/>
                        </a:rPr>
                        <a:t>Validation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 dirty="0">
                          <a:effectLst/>
                        </a:rPr>
                        <a:t>Training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 dirty="0">
                          <a:effectLst/>
                        </a:rPr>
                        <a:t>Test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Validation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3823307190"/>
                  </a:ext>
                </a:extLst>
              </a:tr>
              <a:tr h="447529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1" u="none" strike="noStrike" dirty="0">
                          <a:effectLst/>
                        </a:rPr>
                        <a:t>Tiles</a:t>
                      </a:r>
                      <a:endParaRPr lang="en-GB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4058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855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 dirty="0">
                          <a:effectLst/>
                        </a:rPr>
                        <a:t>1928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 dirty="0">
                          <a:effectLst/>
                        </a:rPr>
                        <a:t>6659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 dirty="0">
                          <a:effectLst/>
                        </a:rPr>
                        <a:t>609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 dirty="0">
                          <a:effectLst/>
                        </a:rPr>
                        <a:t>1039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6659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855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 dirty="0">
                          <a:effectLst/>
                        </a:rPr>
                        <a:t>1928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6659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855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1039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72438812"/>
                  </a:ext>
                </a:extLst>
              </a:tr>
              <a:tr h="447529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1" u="none" strike="noStrike" dirty="0">
                          <a:effectLst/>
                        </a:rPr>
                        <a:t>ROI</a:t>
                      </a:r>
                      <a:endParaRPr lang="en-GB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170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36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 dirty="0">
                          <a:effectLst/>
                        </a:rPr>
                        <a:t>40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237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41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 dirty="0">
                          <a:effectLst/>
                        </a:rPr>
                        <a:t>45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170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36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 dirty="0">
                          <a:effectLst/>
                        </a:rPr>
                        <a:t>40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237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41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45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352832269"/>
                  </a:ext>
                </a:extLst>
              </a:tr>
              <a:tr h="447529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1" u="none" strike="noStrike" dirty="0">
                          <a:effectLst/>
                        </a:rPr>
                        <a:t>Patient</a:t>
                      </a:r>
                      <a:endParaRPr lang="en-GB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72 (29)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15 (4)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 dirty="0">
                          <a:effectLst/>
                        </a:rPr>
                        <a:t>16 (6)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 dirty="0">
                          <a:effectLst/>
                        </a:rPr>
                        <a:t>89 (29)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18 (4)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 dirty="0">
                          <a:effectLst/>
                        </a:rPr>
                        <a:t>18 (6)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72 (29)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15 (4)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 dirty="0">
                          <a:effectLst/>
                        </a:rPr>
                        <a:t>16 (6)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89 (29)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>
                          <a:effectLst/>
                        </a:rPr>
                        <a:t>18 (4)</a:t>
                      </a:r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u="none" strike="noStrike" dirty="0">
                          <a:effectLst/>
                        </a:rPr>
                        <a:t>18 (6)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308180103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86629377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25</Words>
  <Application>Microsoft Office PowerPoint</Application>
  <PresentationFormat>Widescreen</PresentationFormat>
  <Paragraphs>63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ristopher McCombe</dc:creator>
  <cp:lastModifiedBy>Kristopher McCombe</cp:lastModifiedBy>
  <cp:revision>2</cp:revision>
  <dcterms:created xsi:type="dcterms:W3CDTF">2021-06-07T11:56:03Z</dcterms:created>
  <dcterms:modified xsi:type="dcterms:W3CDTF">2021-06-07T12:42:34Z</dcterms:modified>
</cp:coreProperties>
</file>